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14DA3-16C3-4C50-993C-C346FD3D84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B05926-C2F5-4EB7-A107-24E5492B97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E2AD0-9C5F-4F19-8272-BEABFD1CB1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3373C-52D7-4988-B800-8B5D75CBB3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D55AD4-7977-45F8-97BB-1F01334336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0CDFC-B202-49F7-B3FC-5BACD71DD5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D465D-8984-40C8-BA0D-AF0095B502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7A0CA-C665-4922-B1DA-4184FC3E66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7A9FD-26CB-4E34-94E7-BCE097ED18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F85FDE-75CB-4FCE-86F1-0FE4E639EB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7EA44-0B36-4DA3-A2E7-B399B90C27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7A702-7C3D-4D40-AC98-25DB1586C9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4CD61E-3B4D-415A-AF4F-E998421E3E0B}" type="slidenum">
              <a:rPr b="0" lang="pt-B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o 32"/>
          <p:cNvGrpSpPr/>
          <p:nvPr/>
        </p:nvGrpSpPr>
        <p:grpSpPr>
          <a:xfrm>
            <a:off x="2411280" y="806400"/>
            <a:ext cx="4681800" cy="1182600"/>
            <a:chOff x="2411280" y="806400"/>
            <a:chExt cx="4681800" cy="1182600"/>
          </a:xfrm>
        </p:grpSpPr>
        <p:pic>
          <p:nvPicPr>
            <p:cNvPr id="42" name="Imagem 5" descr="LIMPP 2010-04-12 18hr 03minRNAdef.jpg"/>
            <p:cNvPicPr/>
            <p:nvPr/>
          </p:nvPicPr>
          <p:blipFill>
            <a:blip r:embed="rId1"/>
            <a:srcRect l="18979" t="22863" r="22734" b="64368"/>
            <a:stretch/>
          </p:blipFill>
          <p:spPr>
            <a:xfrm>
              <a:off x="2411280" y="1268640"/>
              <a:ext cx="4647600" cy="72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Rectangle 231"/>
            <p:cNvSpPr/>
            <p:nvPr/>
          </p:nvSpPr>
          <p:spPr>
            <a:xfrm>
              <a:off x="2411280" y="1052640"/>
              <a:ext cx="468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Root     Stem   Leaf     Root   Stem    Leaf    Flower  Root    Stem   Leaf     Po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Conector reto 12"/>
            <p:cNvSpPr/>
            <p:nvPr/>
          </p:nvSpPr>
          <p:spPr>
            <a:xfrm>
              <a:off x="2483280" y="1052640"/>
              <a:ext cx="1152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Conector reto 14"/>
            <p:cNvSpPr/>
            <p:nvPr/>
          </p:nvSpPr>
          <p:spPr>
            <a:xfrm>
              <a:off x="3779640" y="1052640"/>
              <a:ext cx="1584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Conector reto 16"/>
            <p:cNvSpPr/>
            <p:nvPr/>
          </p:nvSpPr>
          <p:spPr>
            <a:xfrm>
              <a:off x="5436360" y="1052640"/>
              <a:ext cx="1512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231"/>
            <p:cNvSpPr/>
            <p:nvPr/>
          </p:nvSpPr>
          <p:spPr>
            <a:xfrm>
              <a:off x="2707560" y="806400"/>
              <a:ext cx="71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V4 stag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231"/>
            <p:cNvSpPr/>
            <p:nvPr/>
          </p:nvSpPr>
          <p:spPr>
            <a:xfrm>
              <a:off x="4356000" y="806400"/>
              <a:ext cx="71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R2 stag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231"/>
            <p:cNvSpPr/>
            <p:nvPr/>
          </p:nvSpPr>
          <p:spPr>
            <a:xfrm>
              <a:off x="5877000" y="806400"/>
              <a:ext cx="71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R4 stag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0" name="Grupo 33"/>
          <p:cNvGrpSpPr/>
          <p:nvPr/>
        </p:nvGrpSpPr>
        <p:grpSpPr>
          <a:xfrm>
            <a:off x="2827440" y="2894040"/>
            <a:ext cx="3760560" cy="1613880"/>
            <a:chOff x="2827440" y="2894040"/>
            <a:chExt cx="3760560" cy="1613880"/>
          </a:xfrm>
        </p:grpSpPr>
        <p:pic>
          <p:nvPicPr>
            <p:cNvPr id="51" name="Imagem 4" descr="Usuario 2010-12-14 16hr 57minRNASONEMAREPL3.jpg"/>
            <p:cNvPicPr/>
            <p:nvPr/>
          </p:nvPicPr>
          <p:blipFill>
            <a:blip r:embed="rId2"/>
            <a:srcRect l="17786" t="30850" r="26137" b="54792"/>
            <a:stretch/>
          </p:blipFill>
          <p:spPr>
            <a:xfrm>
              <a:off x="2827440" y="3426120"/>
              <a:ext cx="3760560" cy="72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Rectangle 231"/>
            <p:cNvSpPr/>
            <p:nvPr/>
          </p:nvSpPr>
          <p:spPr>
            <a:xfrm>
              <a:off x="2971440" y="3182040"/>
              <a:ext cx="3600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Mock      MI      Mock      MI      Mock     MI      Mock     MI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Conector reto 18"/>
            <p:cNvSpPr/>
            <p:nvPr/>
          </p:nvSpPr>
          <p:spPr>
            <a:xfrm>
              <a:off x="3043440" y="3140280"/>
              <a:ext cx="72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Conector reto 20"/>
            <p:cNvSpPr/>
            <p:nvPr/>
          </p:nvSpPr>
          <p:spPr>
            <a:xfrm>
              <a:off x="3979440" y="3140280"/>
              <a:ext cx="72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Conector reto 21"/>
            <p:cNvSpPr/>
            <p:nvPr/>
          </p:nvSpPr>
          <p:spPr>
            <a:xfrm>
              <a:off x="4843800" y="3140280"/>
              <a:ext cx="72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Conector reto 22"/>
            <p:cNvSpPr/>
            <p:nvPr/>
          </p:nvSpPr>
          <p:spPr>
            <a:xfrm>
              <a:off x="5707800" y="3140280"/>
              <a:ext cx="720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231"/>
            <p:cNvSpPr/>
            <p:nvPr/>
          </p:nvSpPr>
          <p:spPr>
            <a:xfrm>
              <a:off x="3195720" y="2894040"/>
              <a:ext cx="56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7 DA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231"/>
            <p:cNvSpPr/>
            <p:nvPr/>
          </p:nvSpPr>
          <p:spPr>
            <a:xfrm>
              <a:off x="4060080" y="2894040"/>
              <a:ext cx="63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14 DA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231"/>
            <p:cNvSpPr/>
            <p:nvPr/>
          </p:nvSpPr>
          <p:spPr>
            <a:xfrm>
              <a:off x="4996080" y="2894040"/>
              <a:ext cx="63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21 DA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231"/>
            <p:cNvSpPr/>
            <p:nvPr/>
          </p:nvSpPr>
          <p:spPr>
            <a:xfrm>
              <a:off x="5860440" y="2894040"/>
              <a:ext cx="71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28 DA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 Box 442"/>
            <p:cNvSpPr/>
            <p:nvPr/>
          </p:nvSpPr>
          <p:spPr>
            <a:xfrm>
              <a:off x="2827440" y="4216320"/>
              <a:ext cx="2088360" cy="2916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*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M. incognita </a:t>
              </a: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- inoculated roo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Grupo 34"/>
          <p:cNvGrpSpPr/>
          <p:nvPr/>
        </p:nvGrpSpPr>
        <p:grpSpPr>
          <a:xfrm>
            <a:off x="3276720" y="5343480"/>
            <a:ext cx="3024000" cy="1180800"/>
            <a:chOff x="3276720" y="5343480"/>
            <a:chExt cx="3024000" cy="1180800"/>
          </a:xfrm>
        </p:grpSpPr>
        <p:pic>
          <p:nvPicPr>
            <p:cNvPr id="63" name="Imagem 3" descr="Usuario 2010-10-19 16hr 40minRNASOJAInseto.jpg"/>
            <p:cNvPicPr/>
            <p:nvPr/>
          </p:nvPicPr>
          <p:blipFill>
            <a:blip r:embed="rId3"/>
            <a:srcRect l="13014" t="36679" r="46423" b="53195"/>
            <a:stretch/>
          </p:blipFill>
          <p:spPr>
            <a:xfrm>
              <a:off x="3276720" y="5587200"/>
              <a:ext cx="2808000" cy="577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Rectangle 231"/>
            <p:cNvSpPr/>
            <p:nvPr/>
          </p:nvSpPr>
          <p:spPr>
            <a:xfrm>
              <a:off x="3420720" y="5343480"/>
              <a:ext cx="288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Mock      15 min   30 min   60 min   180 min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ahoma"/>
                  <a:ea typeface="맑은 고딕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 Box 442"/>
            <p:cNvSpPr/>
            <p:nvPr/>
          </p:nvSpPr>
          <p:spPr>
            <a:xfrm>
              <a:off x="3276720" y="6232680"/>
              <a:ext cx="2088000" cy="2916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3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baseline="30000">
                  <a:solidFill>
                    <a:srgbClr val="000000"/>
                  </a:solidFill>
                  <a:latin typeface="Tahoma"/>
                  <a:ea typeface="맑은 고딕"/>
                </a:rPr>
                <a:t>+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A. gemmatalis</a:t>
              </a:r>
              <a:r>
                <a:rPr b="0" lang="en-US" sz="1000" spc="-1" strike="noStrike">
                  <a:solidFill>
                    <a:srgbClr val="000000"/>
                  </a:solidFill>
                  <a:latin typeface="Tahoma"/>
                  <a:ea typeface="맑은 고딕"/>
                </a:rPr>
                <a:t>- infested leaf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" name="Rectangle 231"/>
          <p:cNvSpPr/>
          <p:nvPr/>
        </p:nvSpPr>
        <p:spPr>
          <a:xfrm>
            <a:off x="2052720" y="88092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ahoma"/>
                <a:ea typeface="맑은 고딕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231"/>
          <p:cNvSpPr/>
          <p:nvPr/>
        </p:nvSpPr>
        <p:spPr>
          <a:xfrm>
            <a:off x="2050920" y="2968560"/>
            <a:ext cx="43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ahoma"/>
                <a:ea typeface="맑은 고딕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231"/>
          <p:cNvSpPr/>
          <p:nvPr/>
        </p:nvSpPr>
        <p:spPr>
          <a:xfrm>
            <a:off x="2050920" y="5416560"/>
            <a:ext cx="43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ahoma"/>
                <a:ea typeface="맑은 고딕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09T21:00:32Z</dcterms:created>
  <dc:creator>Miranda</dc:creator>
  <dc:description/>
  <dc:language>en-US</dc:language>
  <cp:lastModifiedBy>vivian</cp:lastModifiedBy>
  <dcterms:modified xsi:type="dcterms:W3CDTF">2011-07-01T15:24:18Z</dcterms:modified>
  <cp:revision>7</cp:revision>
  <dc:subject/>
  <dc:title>Slide 1</dc:title>
</cp:coreProperties>
</file>